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BB003F4-A601-8693-71B4-A79F573FEF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B69C83B1-A3E1-9102-5E2A-8FE46234E3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4B80964-0F31-A624-0363-3E3D8944D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9B0A9FD-8CA8-3AD2-8107-B06EF0657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972F578-6FEA-0864-9B09-03A59F665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8197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96149E3-8F60-5813-0DB1-D388B33296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D1239302-558C-BF90-E53A-E271C421C5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1DC90A1-3AB0-ECCE-3318-9827E1E55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EBFDE430-D629-5020-1DB8-A893A91B5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00F3C7B-2997-8098-1417-BD5C8AE6E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91295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02C58F93-A186-7A16-1982-6B343A4B6D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C771C415-8956-0825-2FEA-CDD1600E41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17048E3-0CE4-D6E1-546D-F558748F5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8F4F555-9C0D-1EE9-1347-61C0E45D5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77D12B48-FBA0-5D53-4B29-2A4DF05B8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39171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11BBA3B-5402-0166-6604-12E5B05FCC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24A9E585-0E1A-3C26-3C72-3DC7B5A9CC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BBCF9B9-FD7F-9E91-1084-B1BF8366E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A0188B9-38BB-939B-DBC5-958E094C3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7F8D70B4-CB37-F8DD-FA58-77280D8AC7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28698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F11D120-15E5-2ABB-9755-21F6D0A90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C50936F-AF7A-099A-DCF8-54B3AB2DB2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8A5B59C-5BA1-AA2A-DA0F-FC2497A4D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971D824-FC43-9ED4-97C1-938BB0EA6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B02DE6E-A87D-AE3E-DF22-E230305FD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68982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D66506C-ED19-F0B9-43EC-5DCFC8B16A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BF928E64-DCB3-DD75-1FCD-0C97EBEAC4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228A416C-E77D-E8E5-6589-C4D469537E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D3B6676-4177-0C04-6C75-AF1A931E5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501AD37-BF8B-34C4-82FE-1B62B1E8C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501F4F6-21F6-EFB5-C88E-322AEB934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20177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D583DD0-F64F-5A5C-AFCA-71D5DCEA5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0199DA7C-2C59-4FF0-592D-F34263C796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E6A435D0-1656-6D0C-5088-3666A80960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5ADD4E47-B9DF-45C1-45AF-1FBC145660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3A37B693-989C-9600-6A92-69C50D86D5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2BFD9C84-1F99-D0F2-111E-168266BA8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D8D4E2D6-5FC1-B90A-514A-64D02F632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D9A5E65E-1DE9-98BA-1058-9D5B2FD29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17651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C1E2BCD3-82CB-1515-2C8D-5FA3AD5D7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B2CCA3B6-8A2D-0D06-DFFC-D9C74AAC3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971C9237-A68A-BC54-10F3-95E89A699F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024EC15E-5B34-CB2E-51B7-578BC8F8C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5790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F90DD206-C4C4-1DD3-A54D-2EA1742B31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6603F3BB-2AF3-1553-4B6E-12EB44F61B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3B7CAF5E-411D-2F67-2855-8E2F174CD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34784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CBF4383-ADF4-C91F-9965-912EBA654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B3CE8CE9-FA6D-53DA-22EC-C158A7F056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5FD573F0-13B3-9BFF-DCFB-D73971A4DE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ACFBD128-2268-064B-62C7-1E7A71527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D48CBE0D-C4F4-4439-CCCD-0262BE034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26451F66-E26B-F016-DEF8-220FC9140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2142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2716398-3FCD-3BED-7C61-8B9358F4B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820055CC-ED9F-5C11-0DAB-6083C674E8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888CBE89-9D1E-7D85-4E75-EDD8565CA1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365D0AB-1E7C-9F62-339B-F80AD52A6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B0DD00D-421C-40CC-2F7C-426B752C0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F4EF593-B486-7EBE-3085-CB56CE8E2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32786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C7863F83-D993-E18C-7D3C-7F6E5F28A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2ED1A913-00E1-88A0-6799-0ABE9C055B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55C5FDF-BE31-F3F8-A318-BA366C9AF9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8A1B7-C875-4F78-B0E6-EDFAD47718FD}" type="datetimeFigureOut">
              <a:rPr lang="hu-HU" smtClean="0"/>
              <a:t>2023. 03. 14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9E62E57-52EE-C571-050C-24005FB5EC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B760EAC-5148-E4EC-A9FC-BA7F306B59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4769F-E97B-4E61-BC32-46A1B186852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42906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zövegdoboz 7">
            <a:extLst>
              <a:ext uri="{FF2B5EF4-FFF2-40B4-BE49-F238E27FC236}">
                <a16:creationId xmlns:a16="http://schemas.microsoft.com/office/drawing/2014/main" id="{6CB489DD-3B7B-9144-4C0D-912C1B6F6C63}"/>
              </a:ext>
            </a:extLst>
          </p:cNvPr>
          <p:cNvSpPr txBox="1"/>
          <p:nvPr/>
        </p:nvSpPr>
        <p:spPr>
          <a:xfrm>
            <a:off x="834502" y="4697120"/>
            <a:ext cx="104312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igure S1: The size of the cells was significantly shorter in the mutant cultures (333,334, 335) (A) (YEA, 30</a:t>
            </a:r>
            <a:r>
              <a:rPr lang="en-AU" baseline="30000" dirty="0"/>
              <a:t>o</a:t>
            </a:r>
            <a:r>
              <a:rPr lang="en-AU" dirty="0"/>
              <a:t>C, 1 day) and (B) (YEA, 30</a:t>
            </a:r>
            <a:r>
              <a:rPr lang="en-AU" baseline="30000" dirty="0"/>
              <a:t>o</a:t>
            </a:r>
            <a:r>
              <a:rPr lang="en-AU" dirty="0"/>
              <a:t>C, 2 days) (</a:t>
            </a:r>
            <a:r>
              <a:rPr lang="en-AU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 values: 0,0004383 (A) and 9,838E-08 (B), while t</a:t>
            </a:r>
            <a:r>
              <a:rPr lang="en-AU" dirty="0"/>
              <a:t>he time necessary for septum degradation (C)(YEA, at 30</a:t>
            </a:r>
            <a:r>
              <a:rPr lang="en-AU" baseline="30000" dirty="0"/>
              <a:t>o</a:t>
            </a:r>
            <a:r>
              <a:rPr lang="en-AU" dirty="0"/>
              <a:t>C) did not differ significantly, compared to the control strain (p-value: 0,10318).</a:t>
            </a:r>
          </a:p>
        </p:txBody>
      </p:sp>
      <p:grpSp>
        <p:nvGrpSpPr>
          <p:cNvPr id="16" name="Csoportba foglalás 15">
            <a:extLst>
              <a:ext uri="{FF2B5EF4-FFF2-40B4-BE49-F238E27FC236}">
                <a16:creationId xmlns:a16="http://schemas.microsoft.com/office/drawing/2014/main" id="{5097F543-F29F-19D5-B0CC-A6A64120EC90}"/>
              </a:ext>
            </a:extLst>
          </p:cNvPr>
          <p:cNvGrpSpPr/>
          <p:nvPr/>
        </p:nvGrpSpPr>
        <p:grpSpPr>
          <a:xfrm>
            <a:off x="8160672" y="522456"/>
            <a:ext cx="3911186" cy="3855763"/>
            <a:chOff x="771101" y="319167"/>
            <a:chExt cx="3911186" cy="3855763"/>
          </a:xfrm>
        </p:grpSpPr>
        <p:pic>
          <p:nvPicPr>
            <p:cNvPr id="12" name="Kép 11">
              <a:extLst>
                <a:ext uri="{FF2B5EF4-FFF2-40B4-BE49-F238E27FC236}">
                  <a16:creationId xmlns:a16="http://schemas.microsoft.com/office/drawing/2014/main" id="{4D246905-22DD-FB41-CDD5-A084326522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3616"/>
            <a:stretch/>
          </p:blipFill>
          <p:spPr>
            <a:xfrm>
              <a:off x="771101" y="319167"/>
              <a:ext cx="3911186" cy="3540531"/>
            </a:xfrm>
            <a:prstGeom prst="rect">
              <a:avLst/>
            </a:prstGeom>
          </p:spPr>
        </p:pic>
        <p:sp>
          <p:nvSpPr>
            <p:cNvPr id="13" name="Szövegdoboz 12">
              <a:extLst>
                <a:ext uri="{FF2B5EF4-FFF2-40B4-BE49-F238E27FC236}">
                  <a16:creationId xmlns:a16="http://schemas.microsoft.com/office/drawing/2014/main" id="{462B085D-A6F2-4312-44B8-46FF15B79FBB}"/>
                </a:ext>
              </a:extLst>
            </p:cNvPr>
            <p:cNvSpPr txBox="1"/>
            <p:nvPr/>
          </p:nvSpPr>
          <p:spPr>
            <a:xfrm>
              <a:off x="1176867" y="319167"/>
              <a:ext cx="62370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600" dirty="0"/>
                <a:t>C </a:t>
              </a:r>
            </a:p>
            <a:p>
              <a:r>
                <a:rPr lang="hu-HU" sz="1600" dirty="0"/>
                <a:t>min</a:t>
              </a:r>
            </a:p>
          </p:txBody>
        </p:sp>
        <p:sp>
          <p:nvSpPr>
            <p:cNvPr id="14" name="Szövegdoboz 13">
              <a:extLst>
                <a:ext uri="{FF2B5EF4-FFF2-40B4-BE49-F238E27FC236}">
                  <a16:creationId xmlns:a16="http://schemas.microsoft.com/office/drawing/2014/main" id="{25134241-C471-99CC-E803-254FACF711D2}"/>
                </a:ext>
              </a:extLst>
            </p:cNvPr>
            <p:cNvSpPr txBox="1"/>
            <p:nvPr/>
          </p:nvSpPr>
          <p:spPr>
            <a:xfrm>
              <a:off x="1474040" y="3867153"/>
              <a:ext cx="2662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400" dirty="0"/>
                <a:t>  </a:t>
              </a:r>
              <a:r>
                <a:rPr lang="hu-HU" sz="1400" dirty="0" err="1"/>
                <a:t>wild-type</a:t>
              </a:r>
              <a:r>
                <a:rPr lang="hu-HU" sz="1400" dirty="0"/>
                <a:t>          </a:t>
              </a:r>
              <a:r>
                <a:rPr lang="hu-HU" sz="1400" dirty="0" err="1"/>
                <a:t>mutant</a:t>
              </a:r>
              <a:r>
                <a:rPr lang="hu-HU" sz="1400" dirty="0"/>
                <a:t> (334) </a:t>
              </a:r>
            </a:p>
          </p:txBody>
        </p:sp>
      </p:grpSp>
      <p:grpSp>
        <p:nvGrpSpPr>
          <p:cNvPr id="2" name="Csoportba foglalás 1">
            <a:extLst>
              <a:ext uri="{FF2B5EF4-FFF2-40B4-BE49-F238E27FC236}">
                <a16:creationId xmlns:a16="http://schemas.microsoft.com/office/drawing/2014/main" id="{F07AAED7-6F30-68AF-4FCB-2D4E9653D5DF}"/>
              </a:ext>
            </a:extLst>
          </p:cNvPr>
          <p:cNvGrpSpPr/>
          <p:nvPr/>
        </p:nvGrpSpPr>
        <p:grpSpPr>
          <a:xfrm>
            <a:off x="469009" y="506164"/>
            <a:ext cx="7960826" cy="4076374"/>
            <a:chOff x="3963742" y="332017"/>
            <a:chExt cx="7960826" cy="4076374"/>
          </a:xfrm>
        </p:grpSpPr>
        <p:grpSp>
          <p:nvGrpSpPr>
            <p:cNvPr id="23" name="Csoportba foglalás 22">
              <a:extLst>
                <a:ext uri="{FF2B5EF4-FFF2-40B4-BE49-F238E27FC236}">
                  <a16:creationId xmlns:a16="http://schemas.microsoft.com/office/drawing/2014/main" id="{ACD974F9-E1AE-F460-E6FF-E3AA10B7B566}"/>
                </a:ext>
              </a:extLst>
            </p:cNvPr>
            <p:cNvGrpSpPr/>
            <p:nvPr/>
          </p:nvGrpSpPr>
          <p:grpSpPr>
            <a:xfrm>
              <a:off x="3963742" y="332017"/>
              <a:ext cx="4111523" cy="4030693"/>
              <a:chOff x="3914889" y="358650"/>
              <a:chExt cx="4111523" cy="4030693"/>
            </a:xfrm>
          </p:grpSpPr>
          <p:grpSp>
            <p:nvGrpSpPr>
              <p:cNvPr id="17" name="Csoportba foglalás 16">
                <a:extLst>
                  <a:ext uri="{FF2B5EF4-FFF2-40B4-BE49-F238E27FC236}">
                    <a16:creationId xmlns:a16="http://schemas.microsoft.com/office/drawing/2014/main" id="{EA472E81-9EC0-5766-4044-46670F8AF704}"/>
                  </a:ext>
                </a:extLst>
              </p:cNvPr>
              <p:cNvGrpSpPr/>
              <p:nvPr/>
            </p:nvGrpSpPr>
            <p:grpSpPr>
              <a:xfrm>
                <a:off x="3914889" y="358650"/>
                <a:ext cx="4111523" cy="3553154"/>
                <a:chOff x="4129764" y="314073"/>
                <a:chExt cx="4111523" cy="3532227"/>
              </a:xfrm>
            </p:grpSpPr>
            <p:pic>
              <p:nvPicPr>
                <p:cNvPr id="4" name="Kép 3">
                  <a:extLst>
                    <a:ext uri="{FF2B5EF4-FFF2-40B4-BE49-F238E27FC236}">
                      <a16:creationId xmlns:a16="http://schemas.microsoft.com/office/drawing/2014/main" id="{26D448F5-4578-B369-2516-E705520F59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14030"/>
                <a:stretch/>
              </p:blipFill>
              <p:spPr>
                <a:xfrm>
                  <a:off x="4129764" y="326622"/>
                  <a:ext cx="4111523" cy="3519678"/>
                </a:xfrm>
                <a:prstGeom prst="rect">
                  <a:avLst/>
                </a:prstGeom>
              </p:spPr>
            </p:pic>
            <p:sp>
              <p:nvSpPr>
                <p:cNvPr id="10" name="Szövegdoboz 9">
                  <a:extLst>
                    <a:ext uri="{FF2B5EF4-FFF2-40B4-BE49-F238E27FC236}">
                      <a16:creationId xmlns:a16="http://schemas.microsoft.com/office/drawing/2014/main" id="{200E431F-8130-E761-35F6-E53CACAE2C66}"/>
                    </a:ext>
                  </a:extLst>
                </p:cNvPr>
                <p:cNvSpPr txBox="1"/>
                <p:nvPr/>
              </p:nvSpPr>
              <p:spPr>
                <a:xfrm>
                  <a:off x="4421956" y="314073"/>
                  <a:ext cx="540706" cy="64252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dirty="0"/>
                    <a:t>A  µm</a:t>
                  </a:r>
                </a:p>
              </p:txBody>
            </p:sp>
          </p:grpSp>
          <p:sp>
            <p:nvSpPr>
              <p:cNvPr id="19" name="Szövegdoboz 18">
                <a:extLst>
                  <a:ext uri="{FF2B5EF4-FFF2-40B4-BE49-F238E27FC236}">
                    <a16:creationId xmlns:a16="http://schemas.microsoft.com/office/drawing/2014/main" id="{373E85A3-8C41-D89A-4040-86A69F070C69}"/>
                  </a:ext>
                </a:extLst>
              </p:cNvPr>
              <p:cNvSpPr txBox="1"/>
              <p:nvPr/>
            </p:nvSpPr>
            <p:spPr>
              <a:xfrm>
                <a:off x="4569919" y="3866123"/>
                <a:ext cx="277389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400" dirty="0"/>
                  <a:t>  </a:t>
                </a:r>
                <a:r>
                  <a:rPr lang="hu-HU" sz="1400" dirty="0" err="1"/>
                  <a:t>wild-type</a:t>
                </a:r>
                <a:r>
                  <a:rPr lang="hu-HU" sz="1400" dirty="0"/>
                  <a:t>  334          333         335        </a:t>
                </a:r>
              </a:p>
              <a:p>
                <a:r>
                  <a:rPr lang="hu-HU" sz="1400" dirty="0"/>
                  <a:t>                                      </a:t>
                </a:r>
                <a:r>
                  <a:rPr lang="hu-HU" sz="1400" dirty="0" err="1"/>
                  <a:t>mutant</a:t>
                </a:r>
                <a:endParaRPr lang="hu-HU" sz="1400" dirty="0"/>
              </a:p>
            </p:txBody>
          </p:sp>
        </p:grpSp>
        <p:grpSp>
          <p:nvGrpSpPr>
            <p:cNvPr id="22" name="Csoportba foglalás 21">
              <a:extLst>
                <a:ext uri="{FF2B5EF4-FFF2-40B4-BE49-F238E27FC236}">
                  <a16:creationId xmlns:a16="http://schemas.microsoft.com/office/drawing/2014/main" id="{6DDA2CCD-B1F4-B0FB-02F5-87CA269659DF}"/>
                </a:ext>
              </a:extLst>
            </p:cNvPr>
            <p:cNvGrpSpPr/>
            <p:nvPr/>
          </p:nvGrpSpPr>
          <p:grpSpPr>
            <a:xfrm>
              <a:off x="7701846" y="344640"/>
              <a:ext cx="4222722" cy="4063751"/>
              <a:chOff x="8052488" y="325592"/>
              <a:chExt cx="4222722" cy="4063751"/>
            </a:xfrm>
          </p:grpSpPr>
          <p:grpSp>
            <p:nvGrpSpPr>
              <p:cNvPr id="18" name="Csoportba foglalás 17">
                <a:extLst>
                  <a:ext uri="{FF2B5EF4-FFF2-40B4-BE49-F238E27FC236}">
                    <a16:creationId xmlns:a16="http://schemas.microsoft.com/office/drawing/2014/main" id="{CDA000CF-A8AE-5A6B-6CA8-C4227064068B}"/>
                  </a:ext>
                </a:extLst>
              </p:cNvPr>
              <p:cNvGrpSpPr/>
              <p:nvPr/>
            </p:nvGrpSpPr>
            <p:grpSpPr>
              <a:xfrm>
                <a:off x="8052488" y="325592"/>
                <a:ext cx="4222722" cy="3540531"/>
                <a:chOff x="7573620" y="284799"/>
                <a:chExt cx="4222722" cy="3614872"/>
              </a:xfrm>
            </p:grpSpPr>
            <p:pic>
              <p:nvPicPr>
                <p:cNvPr id="7" name="Kép 6">
                  <a:extLst>
                    <a:ext uri="{FF2B5EF4-FFF2-40B4-BE49-F238E27FC236}">
                      <a16:creationId xmlns:a16="http://schemas.microsoft.com/office/drawing/2014/main" id="{C58090F2-E330-F472-442C-9249DE442A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b="14030"/>
                <a:stretch/>
              </p:blipFill>
              <p:spPr>
                <a:xfrm>
                  <a:off x="7573620" y="284799"/>
                  <a:ext cx="4222722" cy="3614872"/>
                </a:xfrm>
                <a:prstGeom prst="rect">
                  <a:avLst/>
                </a:prstGeom>
              </p:spPr>
            </p:pic>
            <p:sp>
              <p:nvSpPr>
                <p:cNvPr id="15" name="Szövegdoboz 14">
                  <a:extLst>
                    <a:ext uri="{FF2B5EF4-FFF2-40B4-BE49-F238E27FC236}">
                      <a16:creationId xmlns:a16="http://schemas.microsoft.com/office/drawing/2014/main" id="{45D06D2B-DA62-476A-B5AD-DB899D7BB98E}"/>
                    </a:ext>
                  </a:extLst>
                </p:cNvPr>
                <p:cNvSpPr txBox="1"/>
                <p:nvPr/>
              </p:nvSpPr>
              <p:spPr>
                <a:xfrm>
                  <a:off x="7882777" y="284799"/>
                  <a:ext cx="540706" cy="6599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dirty="0"/>
                    <a:t>B µm</a:t>
                  </a:r>
                </a:p>
              </p:txBody>
            </p:sp>
          </p:grpSp>
          <p:sp>
            <p:nvSpPr>
              <p:cNvPr id="20" name="Szövegdoboz 19">
                <a:extLst>
                  <a:ext uri="{FF2B5EF4-FFF2-40B4-BE49-F238E27FC236}">
                    <a16:creationId xmlns:a16="http://schemas.microsoft.com/office/drawing/2014/main" id="{11B7B9CA-2F26-16BD-0CB0-2FFA64DE00D7}"/>
                  </a:ext>
                </a:extLst>
              </p:cNvPr>
              <p:cNvSpPr txBox="1"/>
              <p:nvPr/>
            </p:nvSpPr>
            <p:spPr>
              <a:xfrm>
                <a:off x="8432683" y="3866123"/>
                <a:ext cx="343676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1400" dirty="0"/>
                  <a:t>  </a:t>
                </a:r>
                <a:r>
                  <a:rPr lang="hu-HU" sz="1400" dirty="0" err="1"/>
                  <a:t>wild-type</a:t>
                </a:r>
                <a:r>
                  <a:rPr lang="hu-HU" sz="1400" dirty="0"/>
                  <a:t>          334          333          335        </a:t>
                </a:r>
              </a:p>
              <a:p>
                <a:r>
                  <a:rPr lang="hu-HU" sz="1400" dirty="0"/>
                  <a:t>                                      </a:t>
                </a:r>
                <a:r>
                  <a:rPr lang="hu-HU" sz="1400" dirty="0" err="1"/>
                  <a:t>mutant</a:t>
                </a:r>
                <a:endParaRPr lang="hu-HU" sz="1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83769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</TotalTime>
  <Words>112</Words>
  <Application>Microsoft Office PowerPoint</Application>
  <PresentationFormat>Szélesvásznú</PresentationFormat>
  <Paragraphs>1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álné dr. Miklós Ida</dc:creator>
  <cp:lastModifiedBy>Gálné dr. Miklós Ida</cp:lastModifiedBy>
  <cp:revision>29</cp:revision>
  <dcterms:created xsi:type="dcterms:W3CDTF">2023-03-11T16:37:35Z</dcterms:created>
  <dcterms:modified xsi:type="dcterms:W3CDTF">2023-03-14T08:05:49Z</dcterms:modified>
</cp:coreProperties>
</file>